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notesMasterIdLst>
    <p:notesMasterId r:id="rId6"/>
  </p:notesMasterIdLst>
  <p:sldIdLst>
    <p:sldId id="269" r:id="rId5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1348"/>
    <p:restoredTop sz="96327"/>
  </p:normalViewPr>
  <p:slideViewPr>
    <p:cSldViewPr snapToGrid="0">
      <p:cViewPr varScale="1">
        <p:scale>
          <a:sx n="87" d="100"/>
          <a:sy n="87" d="100"/>
        </p:scale>
        <p:origin x="227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5EE78E-609C-944D-BC96-311BC06ED1B1}" type="datetimeFigureOut">
              <a:rPr lang="en-US" smtClean="0"/>
              <a:t>5/1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B6102F7-0347-B24A-9C15-15BFC7C2D1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1980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9A9C6-12A9-E34D-8D86-85EBA284C9BF}" type="datetimeFigureOut">
              <a:rPr lang="en-US" smtClean="0"/>
              <a:t>5/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1E801-ACD5-1744-86CE-BA719D32F7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17710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9A9C6-12A9-E34D-8D86-85EBA284C9BF}" type="datetimeFigureOut">
              <a:rPr lang="en-US" smtClean="0"/>
              <a:t>5/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1E801-ACD5-1744-86CE-BA719D32F7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48498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9A9C6-12A9-E34D-8D86-85EBA284C9BF}" type="datetimeFigureOut">
              <a:rPr lang="en-US" smtClean="0"/>
              <a:t>5/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1E801-ACD5-1744-86CE-BA719D32F7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6144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9A9C6-12A9-E34D-8D86-85EBA284C9BF}" type="datetimeFigureOut">
              <a:rPr lang="en-US" smtClean="0"/>
              <a:t>5/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1E801-ACD5-1744-86CE-BA719D32F7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2487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9A9C6-12A9-E34D-8D86-85EBA284C9BF}" type="datetimeFigureOut">
              <a:rPr lang="en-US" smtClean="0"/>
              <a:t>5/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1E801-ACD5-1744-86CE-BA719D32F7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947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9A9C6-12A9-E34D-8D86-85EBA284C9BF}" type="datetimeFigureOut">
              <a:rPr lang="en-US" smtClean="0"/>
              <a:t>5/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1E801-ACD5-1744-86CE-BA719D32F7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75334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9A9C6-12A9-E34D-8D86-85EBA284C9BF}" type="datetimeFigureOut">
              <a:rPr lang="en-US" smtClean="0"/>
              <a:t>5/1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1E801-ACD5-1744-86CE-BA719D32F7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0072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9A9C6-12A9-E34D-8D86-85EBA284C9BF}" type="datetimeFigureOut">
              <a:rPr lang="en-US" smtClean="0"/>
              <a:t>5/1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1E801-ACD5-1744-86CE-BA719D32F7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04821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9A9C6-12A9-E34D-8D86-85EBA284C9BF}" type="datetimeFigureOut">
              <a:rPr lang="en-US" smtClean="0"/>
              <a:t>5/1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1E801-ACD5-1744-86CE-BA719D32F7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77719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9A9C6-12A9-E34D-8D86-85EBA284C9BF}" type="datetimeFigureOut">
              <a:rPr lang="en-US" smtClean="0"/>
              <a:t>5/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1E801-ACD5-1744-86CE-BA719D32F7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15107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9A9C6-12A9-E34D-8D86-85EBA284C9BF}" type="datetimeFigureOut">
              <a:rPr lang="en-US" smtClean="0"/>
              <a:t>5/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1E801-ACD5-1744-86CE-BA719D32F7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0207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9A9C6-12A9-E34D-8D86-85EBA284C9BF}" type="datetimeFigureOut">
              <a:rPr lang="en-US" smtClean="0"/>
              <a:t>5/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01E801-ACD5-1744-86CE-BA719D32F7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37314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C4993AE7-4D58-A4D2-12B2-3F37057B4F0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99773025"/>
              </p:ext>
            </p:extLst>
          </p:nvPr>
        </p:nvGraphicFramePr>
        <p:xfrm>
          <a:off x="623481" y="295966"/>
          <a:ext cx="5089062" cy="1552479"/>
        </p:xfrm>
        <a:graphic>
          <a:graphicData uri="http://schemas.openxmlformats.org/drawingml/2006/table">
            <a:tbl>
              <a:tblPr bandRow="1">
                <a:tableStyleId>{C083E6E3-FA7D-4D7B-A595-EF9225AFEA82}</a:tableStyleId>
              </a:tblPr>
              <a:tblGrid>
                <a:gridCol w="858982">
                  <a:extLst>
                    <a:ext uri="{9D8B030D-6E8A-4147-A177-3AD203B41FA5}">
                      <a16:colId xmlns:a16="http://schemas.microsoft.com/office/drawing/2014/main" val="401302304"/>
                    </a:ext>
                  </a:extLst>
                </a:gridCol>
                <a:gridCol w="528760">
                  <a:extLst>
                    <a:ext uri="{9D8B030D-6E8A-4147-A177-3AD203B41FA5}">
                      <a16:colId xmlns:a16="http://schemas.microsoft.com/office/drawing/2014/main" val="3428299290"/>
                    </a:ext>
                  </a:extLst>
                </a:gridCol>
                <a:gridCol w="528760">
                  <a:extLst>
                    <a:ext uri="{9D8B030D-6E8A-4147-A177-3AD203B41FA5}">
                      <a16:colId xmlns:a16="http://schemas.microsoft.com/office/drawing/2014/main" val="3529764674"/>
                    </a:ext>
                  </a:extLst>
                </a:gridCol>
                <a:gridCol w="528760">
                  <a:extLst>
                    <a:ext uri="{9D8B030D-6E8A-4147-A177-3AD203B41FA5}">
                      <a16:colId xmlns:a16="http://schemas.microsoft.com/office/drawing/2014/main" val="3819703096"/>
                    </a:ext>
                  </a:extLst>
                </a:gridCol>
                <a:gridCol w="528760">
                  <a:extLst>
                    <a:ext uri="{9D8B030D-6E8A-4147-A177-3AD203B41FA5}">
                      <a16:colId xmlns:a16="http://schemas.microsoft.com/office/drawing/2014/main" val="2605099518"/>
                    </a:ext>
                  </a:extLst>
                </a:gridCol>
                <a:gridCol w="528760">
                  <a:extLst>
                    <a:ext uri="{9D8B030D-6E8A-4147-A177-3AD203B41FA5}">
                      <a16:colId xmlns:a16="http://schemas.microsoft.com/office/drawing/2014/main" val="3866755878"/>
                    </a:ext>
                  </a:extLst>
                </a:gridCol>
                <a:gridCol w="528760">
                  <a:extLst>
                    <a:ext uri="{9D8B030D-6E8A-4147-A177-3AD203B41FA5}">
                      <a16:colId xmlns:a16="http://schemas.microsoft.com/office/drawing/2014/main" val="3142174350"/>
                    </a:ext>
                  </a:extLst>
                </a:gridCol>
                <a:gridCol w="528760">
                  <a:extLst>
                    <a:ext uri="{9D8B030D-6E8A-4147-A177-3AD203B41FA5}">
                      <a16:colId xmlns:a16="http://schemas.microsoft.com/office/drawing/2014/main" val="313086575"/>
                    </a:ext>
                  </a:extLst>
                </a:gridCol>
                <a:gridCol w="528760">
                  <a:extLst>
                    <a:ext uri="{9D8B030D-6E8A-4147-A177-3AD203B41FA5}">
                      <a16:colId xmlns:a16="http://schemas.microsoft.com/office/drawing/2014/main" val="571080913"/>
                    </a:ext>
                  </a:extLst>
                </a:gridCol>
              </a:tblGrid>
              <a:tr h="171308">
                <a:tc gridSpan="9"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ble S5. Percentage of group 3-MB cells expressing # of type I MAGEs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% of cells expressing (number) of type I MAGEs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90152929"/>
                  </a:ext>
                </a:extLst>
              </a:tr>
              <a:tr h="171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of MAGEs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V11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J17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J917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J617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V29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H1205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V34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H825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0312966"/>
                  </a:ext>
                </a:extLst>
              </a:tr>
              <a:tr h="171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.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.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.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.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658444615"/>
                  </a:ext>
                </a:extLst>
              </a:tr>
              <a:tr h="171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.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.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.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extLst>
                  <a:ext uri="{0D108BD9-81ED-4DB2-BD59-A6C34878D82A}">
                    <a16:rowId xmlns:a16="http://schemas.microsoft.com/office/drawing/2014/main" val="2874964262"/>
                  </a:ext>
                </a:extLst>
              </a:tr>
              <a:tr h="171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extLst>
                  <a:ext uri="{0D108BD9-81ED-4DB2-BD59-A6C34878D82A}">
                    <a16:rowId xmlns:a16="http://schemas.microsoft.com/office/drawing/2014/main" val="650549376"/>
                  </a:ext>
                </a:extLst>
              </a:tr>
              <a:tr h="171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extLst>
                  <a:ext uri="{0D108BD9-81ED-4DB2-BD59-A6C34878D82A}">
                    <a16:rowId xmlns:a16="http://schemas.microsoft.com/office/drawing/2014/main" val="4190763276"/>
                  </a:ext>
                </a:extLst>
              </a:tr>
              <a:tr h="171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extLst>
                  <a:ext uri="{0D108BD9-81ED-4DB2-BD59-A6C34878D82A}">
                    <a16:rowId xmlns:a16="http://schemas.microsoft.com/office/drawing/2014/main" val="1225882659"/>
                  </a:ext>
                </a:extLst>
              </a:tr>
              <a:tr h="171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extLst>
                  <a:ext uri="{0D108BD9-81ED-4DB2-BD59-A6C34878D82A}">
                    <a16:rowId xmlns:a16="http://schemas.microsoft.com/office/drawing/2014/main" val="3952631575"/>
                  </a:ext>
                </a:extLst>
              </a:tr>
              <a:tr h="1820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 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2579602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F1F2BF44-0DC6-EB4C-4B82-350812401B08}"/>
              </a:ext>
            </a:extLst>
          </p:cNvPr>
          <p:cNvSpPr txBox="1"/>
          <p:nvPr/>
        </p:nvSpPr>
        <p:spPr>
          <a:xfrm>
            <a:off x="3189887" y="9719846"/>
            <a:ext cx="13152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Supp. Table 5</a:t>
            </a:r>
          </a:p>
        </p:txBody>
      </p:sp>
    </p:spTree>
    <p:extLst>
      <p:ext uri="{BB962C8B-B14F-4D97-AF65-F5344CB8AC3E}">
        <p14:creationId xmlns:p14="http://schemas.microsoft.com/office/powerpoint/2010/main" val="11516575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02CDDD2EDEB75439D8D4E2B9FCF50D0" ma:contentTypeVersion="14" ma:contentTypeDescription="Create a new document." ma:contentTypeScope="" ma:versionID="87d620ee415522c6010d2637fb198116">
  <xsd:schema xmlns:xsd="http://www.w3.org/2001/XMLSchema" xmlns:xs="http://www.w3.org/2001/XMLSchema" xmlns:p="http://schemas.microsoft.com/office/2006/metadata/properties" xmlns:ns2="80fe2a34-9ed1-467a-aea7-88d0586c3294" xmlns:ns3="a96831b6-935d-4da2-9a33-4d9a35328e51" targetNamespace="http://schemas.microsoft.com/office/2006/metadata/properties" ma:root="true" ma:fieldsID="ecef77f0a34e0062b1ddee8748364306" ns2:_="" ns3:_="">
    <xsd:import namespace="80fe2a34-9ed1-467a-aea7-88d0586c3294"/>
    <xsd:import namespace="a96831b6-935d-4da2-9a33-4d9a35328e51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lcf76f155ced4ddcb4097134ff3c332f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ServiceLocation" minOccurs="0"/>
                <xsd:element ref="ns2:MediaServiceSearchProperties" minOccurs="0"/>
                <xsd:element ref="ns2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0fe2a34-9ed1-467a-aea7-88d0586c329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4" nillable="true" ma:taxonomy="true" ma:internalName="lcf76f155ced4ddcb4097134ff3c332f" ma:taxonomyFieldName="MediaServiceImageTags" ma:displayName="Image Tags" ma:readOnly="false" ma:fieldId="{5cf76f15-5ced-4ddc-b409-7134ff3c332f}" ma:taxonomyMulti="true" ma:sspId="f7c65ed7-e385-4001-9a0e-797913405518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8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Location" ma:index="19" nillable="true" ma:displayName="Location" ma:indexed="true" ma:internalName="MediaServiceLocation" ma:readOnly="true">
      <xsd:simpleType>
        <xsd:restriction base="dms:Text"/>
      </xsd:simpleType>
    </xsd:element>
    <xsd:element name="MediaServiceSearchProperties" ma:index="2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96831b6-935d-4da2-9a33-4d9a35328e51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80fe2a34-9ed1-467a-aea7-88d0586c3294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3439A014-3B74-4CF9-82E9-470093E860F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0fe2a34-9ed1-467a-aea7-88d0586c3294"/>
    <ds:schemaRef ds:uri="a96831b6-935d-4da2-9a33-4d9a35328e5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8BA452F5-6950-4A8E-B673-A7EB80C7AC54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97D873F3-BE27-46B5-B6C1-1A6AB32CFF2B}">
  <ds:schemaRefs>
    <ds:schemaRef ds:uri="http://schemas.microsoft.com/office/2006/metadata/properties"/>
    <ds:schemaRef ds:uri="http://schemas.microsoft.com/office/infopath/2007/PartnerControls"/>
    <ds:schemaRef ds:uri="80fe2a34-9ed1-467a-aea7-88d0586c3294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89527</TotalTime>
  <Words>93</Words>
  <Application>Microsoft Macintosh PowerPoint</Application>
  <PresentationFormat>Custom</PresentationFormat>
  <Paragraphs>7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e, Rebecca</dc:creator>
  <cp:lastModifiedBy>Fon Tacer, Klementina</cp:lastModifiedBy>
  <cp:revision>32</cp:revision>
  <dcterms:created xsi:type="dcterms:W3CDTF">2024-05-10T20:09:48Z</dcterms:created>
  <dcterms:modified xsi:type="dcterms:W3CDTF">2025-05-01T21:10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02CDDD2EDEB75439D8D4E2B9FCF50D0</vt:lpwstr>
  </property>
</Properties>
</file>